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27"/>
  </p:normalViewPr>
  <p:slideViewPr>
    <p:cSldViewPr snapToGrid="0" showGuides="1">
      <p:cViewPr varScale="1">
        <p:scale>
          <a:sx n="110" d="100"/>
          <a:sy n="110" d="100"/>
        </p:scale>
        <p:origin x="632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9025B-B628-4160-B186-5844DFC13BAF}" type="datetimeFigureOut">
              <a:rPr lang="zh-CN" altLang="en-US" smtClean="0"/>
              <a:t>2021/3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003D-8D68-4CED-A56A-C7B115A894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0299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9025B-B628-4160-B186-5844DFC13BAF}" type="datetimeFigureOut">
              <a:rPr lang="zh-CN" altLang="en-US" smtClean="0"/>
              <a:t>2021/3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003D-8D68-4CED-A56A-C7B115A894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68064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9025B-B628-4160-B186-5844DFC13BAF}" type="datetimeFigureOut">
              <a:rPr lang="zh-CN" altLang="en-US" smtClean="0"/>
              <a:t>2021/3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003D-8D68-4CED-A56A-C7B115A894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4516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9025B-B628-4160-B186-5844DFC13BAF}" type="datetimeFigureOut">
              <a:rPr lang="zh-CN" altLang="en-US" smtClean="0"/>
              <a:t>2021/3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003D-8D68-4CED-A56A-C7B115A894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31983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9025B-B628-4160-B186-5844DFC13BAF}" type="datetimeFigureOut">
              <a:rPr lang="zh-CN" altLang="en-US" smtClean="0"/>
              <a:t>2021/3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003D-8D68-4CED-A56A-C7B115A894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1059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9025B-B628-4160-B186-5844DFC13BAF}" type="datetimeFigureOut">
              <a:rPr lang="zh-CN" altLang="en-US" smtClean="0"/>
              <a:t>2021/3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003D-8D68-4CED-A56A-C7B115A894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9684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9025B-B628-4160-B186-5844DFC13BAF}" type="datetimeFigureOut">
              <a:rPr lang="zh-CN" altLang="en-US" smtClean="0"/>
              <a:t>2021/3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003D-8D68-4CED-A56A-C7B115A894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0215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9025B-B628-4160-B186-5844DFC13BAF}" type="datetimeFigureOut">
              <a:rPr lang="zh-CN" altLang="en-US" smtClean="0"/>
              <a:t>2021/3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003D-8D68-4CED-A56A-C7B115A894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70261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9025B-B628-4160-B186-5844DFC13BAF}" type="datetimeFigureOut">
              <a:rPr lang="zh-CN" altLang="en-US" smtClean="0"/>
              <a:t>2021/3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003D-8D68-4CED-A56A-C7B115A894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02794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9025B-B628-4160-B186-5844DFC13BAF}" type="datetimeFigureOut">
              <a:rPr lang="zh-CN" altLang="en-US" smtClean="0"/>
              <a:t>2021/3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003D-8D68-4CED-A56A-C7B115A894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7879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9025B-B628-4160-B186-5844DFC13BAF}" type="datetimeFigureOut">
              <a:rPr lang="zh-CN" altLang="en-US" smtClean="0"/>
              <a:t>2021/3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0003D-8D68-4CED-A56A-C7B115A894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0910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19025B-B628-4160-B186-5844DFC13BAF}" type="datetimeFigureOut">
              <a:rPr lang="zh-CN" altLang="en-US" smtClean="0"/>
              <a:t>2021/3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B0003D-8D68-4CED-A56A-C7B115A894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2251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H:\geo\SLC1A5\KMplotter\affyarry\breast-OS.tiff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2044" y="332660"/>
            <a:ext cx="2166934" cy="2200653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文本框 4"/>
          <p:cNvSpPr txBox="1"/>
          <p:nvPr/>
        </p:nvSpPr>
        <p:spPr>
          <a:xfrm>
            <a:off x="474091" y="163195"/>
            <a:ext cx="5516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3155989" y="134366"/>
            <a:ext cx="403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 descr="H:\geo\SLC1A5\KMplotter\affyarry\Breast RFS.tiff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1443" y="332661"/>
            <a:ext cx="2194408" cy="2200653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图片 9" descr="H:\geo\SLC1A5\KMplotter\affyarry\gastric PPF.tiff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62130" y="262525"/>
            <a:ext cx="2187015" cy="227079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图片 10" descr="H:\geo\SLC1A5\KMplotter\affyarry\gastric FP.tiff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2044" y="3099816"/>
            <a:ext cx="2249449" cy="2322576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图片 11" descr="H:\geo\SLC1A5\KMplotter\affyarry\LUNG OS.tiff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83718" y="3107693"/>
            <a:ext cx="2314699" cy="2314699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图片 12" descr="H:\geo\SLC1A5\KMplotter\affyarry\gastric OS.tiff"/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78670" y="262525"/>
            <a:ext cx="2235995" cy="2270789"/>
          </a:xfrm>
          <a:prstGeom prst="rect">
            <a:avLst/>
          </a:prstGeom>
          <a:noFill/>
          <a:ln>
            <a:noFill/>
          </a:ln>
        </p:spPr>
      </p:pic>
      <p:sp>
        <p:nvSpPr>
          <p:cNvPr id="14" name="文本框 13"/>
          <p:cNvSpPr txBox="1"/>
          <p:nvPr/>
        </p:nvSpPr>
        <p:spPr>
          <a:xfrm>
            <a:off x="8886690" y="134366"/>
            <a:ext cx="403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5949568" y="134366"/>
            <a:ext cx="403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图片 14" descr="H:\geo\SLC1A5\KMplotter\affyarry\LUNG FP.tiff"/>
          <p:cNvPicPr/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5475" y="3164562"/>
            <a:ext cx="2321837" cy="2321837"/>
          </a:xfrm>
          <a:prstGeom prst="rect">
            <a:avLst/>
          </a:prstGeom>
          <a:noFill/>
          <a:ln>
            <a:noFill/>
          </a:ln>
        </p:spPr>
      </p:pic>
      <p:pic>
        <p:nvPicPr>
          <p:cNvPr id="16" name="图片 15" descr="H:\geo\SLC1A5\KMplotter\affyarry\ovarian OS.tiff"/>
          <p:cNvPicPr/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60552" y="3164562"/>
            <a:ext cx="2257829" cy="2257829"/>
          </a:xfrm>
          <a:prstGeom prst="rect">
            <a:avLst/>
          </a:prstGeom>
          <a:noFill/>
          <a:ln>
            <a:noFill/>
          </a:ln>
        </p:spPr>
      </p:pic>
      <p:sp>
        <p:nvSpPr>
          <p:cNvPr id="17" name="文本框 16"/>
          <p:cNvSpPr txBox="1"/>
          <p:nvPr/>
        </p:nvSpPr>
        <p:spPr>
          <a:xfrm>
            <a:off x="474091" y="3136521"/>
            <a:ext cx="5516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155989" y="3107692"/>
            <a:ext cx="403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8886690" y="3107692"/>
            <a:ext cx="403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5949568" y="3107692"/>
            <a:ext cx="403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826007" y="5499981"/>
            <a:ext cx="1052313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1. </a:t>
            </a:r>
            <a:r>
              <a:rPr lang="en-US" altLang="zh-CN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survival curves comparing the high and low expression of SLC1A5 in different types of cancer in Kaplan-Meier Plotter databases. (A, B) OS and RFS survival curves of breast cancer (n=1402, n=3951). (C-E) OS, PPS and FP survival curves of gastric cancer (n=875, n=498, n=640). (F, G) OS and FP survival curves of lung cancer (n=1925, n=982). (H) OS survival curve of ovarian cancer (n=1656). OS, overall survival; RFS, relapse-free survival; PPS, post-progression survival; FP, first progression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05293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28</TotalTime>
  <Words>137</Words>
  <Application>Microsoft Macintosh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and Legend</dc:title>
  <dc:creator>ZJS</dc:creator>
  <cp:lastModifiedBy>Happy</cp:lastModifiedBy>
  <cp:revision>38</cp:revision>
  <dcterms:created xsi:type="dcterms:W3CDTF">2020-07-11T02:18:42Z</dcterms:created>
  <dcterms:modified xsi:type="dcterms:W3CDTF">2021-03-11T07:23:46Z</dcterms:modified>
</cp:coreProperties>
</file>